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88852F95-AFC9-4680-B8A3-D735E16D880D}"/>
    <pc:docChg chg="custSel modSld">
      <pc:chgData name="Semertzidou, Anysia" userId="a7f71f62-1794-4728-88f7-f0b545a7c8aa" providerId="ADAL" clId="{88852F95-AFC9-4680-B8A3-D735E16D880D}" dt="2025-10-30T16:00:52.447" v="29" actId="113"/>
      <pc:docMkLst>
        <pc:docMk/>
      </pc:docMkLst>
      <pc:sldChg chg="addSp modSp mod">
        <pc:chgData name="Semertzidou, Anysia" userId="a7f71f62-1794-4728-88f7-f0b545a7c8aa" providerId="ADAL" clId="{88852F95-AFC9-4680-B8A3-D735E16D880D}" dt="2025-10-30T16:00:52.447" v="29" actId="113"/>
        <pc:sldMkLst>
          <pc:docMk/>
          <pc:sldMk cId="2661316615" sldId="256"/>
        </pc:sldMkLst>
        <pc:spChg chg="add mod">
          <ac:chgData name="Semertzidou, Anysia" userId="a7f71f62-1794-4728-88f7-f0b545a7c8aa" providerId="ADAL" clId="{88852F95-AFC9-4680-B8A3-D735E16D880D}" dt="2025-10-30T16:00:30.759" v="2" actId="20577"/>
          <ac:spMkLst>
            <pc:docMk/>
            <pc:sldMk cId="2661316615" sldId="256"/>
            <ac:spMk id="3" creationId="{870CFBC8-F411-3BC8-7302-EFFC3216421E}"/>
          </ac:spMkLst>
        </pc:spChg>
        <pc:spChg chg="mod">
          <ac:chgData name="Semertzidou, Anysia" userId="a7f71f62-1794-4728-88f7-f0b545a7c8aa" providerId="ADAL" clId="{88852F95-AFC9-4680-B8A3-D735E16D880D}" dt="2025-10-30T16:00:52.447" v="29" actId="113"/>
          <ac:spMkLst>
            <pc:docMk/>
            <pc:sldMk cId="2661316615" sldId="256"/>
            <ac:spMk id="5" creationId="{DEA6E99A-4070-CC14-BAC6-E4FB4CE3F52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BF1565-D221-78F0-1920-0F57EB14A7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4FC690-9B0D-BA2B-1DDE-3DE1926A01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18A49A-9DB9-9119-3744-2BD90A0D6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4F6C98-D767-EC86-2AC1-D974F9568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876565-4B55-6A3D-9711-D0ED9777A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7440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6F169-4EB3-E0D0-0354-EEBDD7CC2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A1F210-B19E-5098-EA2E-8E844E8086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8777D-A9BB-026D-4C95-8D0A4FB07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CFBA3E-325F-B8F3-236C-CE01E7F36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2BA64D-C77C-F9B9-76B9-6892980B7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7361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BB6B01-DFFA-654A-46B6-B37E1939EC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7B5A74-E570-C22B-2599-5396BF4D86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66813D-4F0E-E779-BE2A-FF111519F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FA0AB2-C95B-03CC-BFE7-4DEA9C5D6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7353A1-58D3-113A-7658-0E52FC853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6145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F885D-CABB-0B8F-6E80-ED230A7EC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0B2750-9E7F-0E4B-8EAD-2FBDB35B49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333724-C334-0465-F17C-DAE462104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B6B291-7DF7-4DF0-9662-1CEE88E2F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139199-4062-E034-0247-657711727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4297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C837F-59CF-1F76-2A89-53420B7D4C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37B51D-F661-50BB-1800-E9321F3375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629756-D5BB-899F-03A5-E0D65DFC2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B86211-8168-250F-CB99-0896C56C8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B0A8AF-CD2F-9FFA-2231-72DF6F7EA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1369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AC45A3-253A-CEE7-432B-C0B5EA1D63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CA5FEB-1ADD-073F-6F9F-1CB3B4C8FA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568876-7D46-40C3-B364-E37A763189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587399-D3E2-9A90-8850-225E23AD3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04B309-3C4B-1A08-D610-F7639D029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6F88FE-0999-2875-63E3-B9C86EE51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064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F718A-0358-E187-26ED-AE9EA52EBC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3C0172-52E0-DB59-8258-35F74B2C8A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693BFC-846C-C0D6-2574-C856739143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B12096-5507-6765-AC75-C2F54ECD45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76E1C9-4071-9501-992D-C0A89D91C9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11AEF1-9B6A-AD30-1DC7-6FAEECFD9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66AE41-F3D9-906C-C858-0B5175436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7441E7-970E-B714-DDBA-86686B5B5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9896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88848C-8C7F-0885-AD30-7F91524423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482396-897B-F359-4AC3-D5B989649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42934E-0CC6-8F2F-F3AD-6EE8EAC83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16D7F2-4B61-29A8-99DD-576DF07FA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3783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66EF0F-92E7-429C-5B3D-193B595DD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1DB70D-0283-9648-8B98-223A26EAF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33DFA4-FEB7-F48F-E70C-DEEC1D836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6696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372C-C9D4-5FBA-E30A-D17E17B897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C35B5E-5667-CB6D-A98C-8A8529E6D1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BB5D41-1A92-A745-C065-99A3EAC0BC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631AB6-1F13-0A96-BC41-3750B9F31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A8D6B2-A638-6A7C-82C7-F2525D00C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F4ED21-6B8A-1C7E-16B5-536D5518F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2214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783A0-011D-A416-2D18-C92FD5407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94E786C-498F-66B7-D781-C8F7E1C8FF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60E300-1EBC-ED17-FBF8-54B6C85C17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71515B-B685-3EBA-F5CD-5B1DB1B85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8B4A5A-06DF-5D2A-49A9-0E9E245B6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B854F8-CBCB-509C-56A1-7E9B6C68E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0605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1C8F45-1482-05E6-B357-CB621C8D3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258EFF-7EFA-267A-5434-5078B8CF3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7DDC0-CF60-018A-76BF-5E156DEDF5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7CF28F-335C-4129-B0BC-4B1D3A6E180A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7B0662-6A7A-1803-42ED-BB6029BB5C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F3A5D9-657E-D4CA-C2D2-7A96EB8FB1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8A9512-4122-47D5-8EFC-D3BCA6E64F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074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a diagram&#10;&#10;Description automatically generated with medium confidence">
            <a:extLst>
              <a:ext uri="{FF2B5EF4-FFF2-40B4-BE49-F238E27FC236}">
                <a16:creationId xmlns:a16="http://schemas.microsoft.com/office/drawing/2014/main" id="{7B0BD887-2617-7ED5-250A-01EDB82C76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0995" y="694857"/>
            <a:ext cx="5731510" cy="4525010"/>
          </a:xfrm>
          <a:prstGeom prst="rect">
            <a:avLst/>
          </a:prstGeom>
        </p:spPr>
      </p:pic>
      <p:sp>
        <p:nvSpPr>
          <p:cNvPr id="5" name="Text Box 11">
            <a:extLst>
              <a:ext uri="{FF2B5EF4-FFF2-40B4-BE49-F238E27FC236}">
                <a16:creationId xmlns:a16="http://schemas.microsoft.com/office/drawing/2014/main" id="{DEA6E99A-4070-CC14-BAC6-E4FB4CE3F5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7559" y="5600967"/>
            <a:ext cx="5549900" cy="5842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Figure 1</a:t>
            </a:r>
            <a:r>
              <a:rPr lang="en-GB" sz="1100" i="1" kern="100" dirty="0"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shows the r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elationship between the density of proliferating (KI67+) cells and the average expression of genes found to characterise inflammatory CAFs in [24]</a:t>
            </a:r>
            <a:endParaRPr lang="en-GB" sz="11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70CFBC8-F411-3BC8-7302-EFFC3216421E}"/>
              </a:ext>
            </a:extLst>
          </p:cNvPr>
          <p:cNvSpPr txBox="1"/>
          <p:nvPr/>
        </p:nvSpPr>
        <p:spPr>
          <a:xfrm>
            <a:off x="3741821" y="272534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Figure 1</a:t>
            </a:r>
            <a:r>
              <a:rPr lang="en-GB" sz="18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1316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3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3:05:02Z</dcterms:created>
  <dcterms:modified xsi:type="dcterms:W3CDTF">2025-10-30T16:00:57Z</dcterms:modified>
</cp:coreProperties>
</file>